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heme/theme2.xml" ContentType="application/vnd.openxmlformats-officedocument.theme+xml"/>
  <Override PartName="/ppt/tags/tag12.xml" ContentType="application/vnd.openxmlformats-officedocument.presentationml.tags+xml"/>
  <Override PartName="/ppt/theme/theme3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1.xml" ContentType="application/vnd.openxmlformats-officedocument.presentationml.notesSlide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notesSlides/notesSlide2.xml" ContentType="application/vnd.openxmlformats-officedocument.presentationml.notesSlide+xml"/>
  <Override PartName="/ppt/tags/tag1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5"/>
  </p:notesMasterIdLst>
  <p:handoutMasterIdLst>
    <p:handoutMasterId r:id="rId6"/>
  </p:handoutMasterIdLst>
  <p:sldIdLst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7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3.xml"/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85F598C-FC74-47F5-87D9-ADD1D889711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CE778D-C0A4-4351-A025-0B466FA7EF6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4FB9E4-8341-4161-8324-840DC5690B5D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5B2117-38DA-4396-B05A-2405EB5B7C6F}"/>
              </a:ext>
            </a:extLst>
          </p:cNvPr>
          <p:cNvSpPr>
            <a:spLocks noGrp="1"/>
          </p:cNvSpPr>
          <p:nvPr>
            <p:ph type="ftr" sz="quarter" idx="2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 sz="800">
                <a:solidFill>
                  <a:srgbClr val="7F7F7F"/>
                </a:solidFill>
                <a:latin typeface="Arial" panose="020B0604020202020204" pitchFamily="34" charset="0"/>
              </a:rPr>
              <a:t>Amgen Proprietary - For Internal Use Only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4B3161-D9D2-4EFD-902D-68962FCD6E3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D6CE12-2D99-4B55-8570-AE15104F1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540961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2.xml"/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D92673-3000-44CB-8D0D-1517DCF903C7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12D6DA-254A-421F-8CEE-FEFD39633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999087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5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8685213"/>
            <a:ext cx="6858000" cy="458787"/>
          </a:xfrm>
        </p:spPr>
        <p:txBody>
          <a:bodyPr/>
          <a:lstStyle/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2D6DA-254A-421F-8CEE-FEFD39633B7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7812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8685213"/>
            <a:ext cx="6858000" cy="458787"/>
          </a:xfrm>
        </p:spPr>
        <p:txBody>
          <a:bodyPr/>
          <a:lstStyle/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2D6DA-254A-421F-8CEE-FEFD39633B7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608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1DAE24-4CB8-42F8-B4AE-064883C63D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9D5CDC-8D35-42EB-8E09-B1F3F05E10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F9136-A02C-4DC4-8132-A5FE85702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17FC5-7F81-416D-945E-FC23A12FEABA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20E4DB-C604-499A-89D5-D0A3686F0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517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C7E4B-D1D9-4F51-AA43-09CF8A29DF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1BD22B-1449-457E-BE49-C90ED1BFF2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5B0E1-764D-4B7B-86B7-C34DD9E72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1DDEEF-146B-4DEF-90C6-E300A795BD7D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C84863-3DE0-48A8-B528-C83948FC8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289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44308B-8B11-4FED-BEC6-4093519B66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D160C1-7FF7-4BF8-B9F6-65730A925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D7DD24-2768-48C8-AC85-366D225E8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86FF4B-F377-4D6B-91B0-2C0690AA600D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CF137-3B3F-43AD-A323-B746CE54F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22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FD79A-CA4E-4B89-9264-9902489E0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BDAD3D-29AA-4076-9447-8525B6BC1F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109623-CF73-4304-B9B2-F62E49436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FC97A2-BAE6-410E-891A-24B8F0A8EB71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BF8C6D-2D25-4E24-A17A-9E929FC0F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354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D8776-03F4-40D7-AC35-5B1D68923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78A740-1D4E-41E2-977D-EBCC5B55E3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5F445D-947E-40A3-A872-2A72D835F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E4931-E797-4842-9926-7018F3C98E9E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8A613A-85BD-4656-9716-8471E7CFF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11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8BCCD7-433D-47BF-8558-08FBF0AAB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79352A-7FAA-4191-A7B4-8551B40461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6E98AC-CA2D-47DC-A187-6D2FA3805F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B38A72-236D-4EDB-AACC-CD42AAF50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D782BF-6BB4-4685-857A-631E42E55517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56B8CE-9D82-4696-8BA6-C25937B3C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622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E1467D-20EC-4734-BE62-6E3C9C576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9F0582-0C2E-49B4-960D-C5CCAF8B6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E2D088-FA6E-472C-A599-9357C2F24E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85DC7E-D39A-4FE9-A290-6025BC974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933A67-1C60-4553-8E65-79AC80C78B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3A7565-A881-4C21-BEEB-5596BEF8A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CA4508-51F6-41F8-9A4C-3B0677285B88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8376AC-D07C-4592-8C81-AA9755856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342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FD85D2-00E8-408D-938F-8154D588C9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3C290B-9D88-45C4-92EC-940E97C7B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DECFCB-89A8-43A5-8BBD-3807639D8CA0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64672C-CCFE-4CCC-9AD9-3796B39CA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600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B5DB69-C475-40EB-A2A8-61419FA38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22B34C-2842-46AF-8ADD-65A468EF4579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7DC6DC-7173-4D39-9F3C-1710EAAD8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8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3DFA7-8C06-4F8A-9ED5-528E808BD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BF3A6E-067B-4163-8E15-57C34BA8EC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79AA76-CEC4-467B-AB25-FDD8726EDE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97D5EF-6F9A-41A0-B4E3-8AC7EBAC5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307DDA-9B5F-455B-BC1C-216C3540AC0D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59C63C-C0B6-44E9-A269-9DB065DD6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80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C24437-0F2D-4560-8C05-547039D23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C44CEA-ED64-4DE0-8D38-180DBFEC7A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A5A803-D00F-43D8-95D8-9150BA3DB7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A3C932-F940-469D-8EA7-93E107A69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76B66A-F7F6-4090-B9AB-23EED001DD11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649027-C48B-4482-979C-A78FC2ED0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926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B6834F-3363-47CE-AC1D-421EB7A02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5ACB8A-F537-4D08-97A1-83D173B911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63B786-47E0-42A9-8AAC-F09E4B222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383F9-F588-4306-9F85-C4A80B02BE8E}" type="datetimeFigureOut">
              <a:rPr lang="en-US" smtClean="0"/>
              <a:t>10/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2AD0B4-F2AF-43B3-98C6-22A0B5A50A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Amgen Proprietary - For Internal Use Only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3FFE11-D865-4A49-9D38-C85A1468C2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66BB-EBCB-42D7-9DF9-DA015CD2A1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028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6.xml"/><Relationship Id="rId5" Type="http://schemas.openxmlformats.org/officeDocument/2006/relationships/image" Target="../media/image2.emf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DA0042-3B71-485C-BD2C-C434CCFD9D93}"/>
              </a:ext>
            </a:extLst>
          </p:cNvPr>
          <p:cNvSpPr txBox="1"/>
          <p:nvPr/>
        </p:nvSpPr>
        <p:spPr>
          <a:xfrm>
            <a:off x="884583" y="695739"/>
            <a:ext cx="7448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 Table 1. Glycosylation Occupancy Profiling by Mass Spec analysis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A708DEB-935D-4C1D-9506-D39A083F3A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2981213"/>
              </p:ext>
            </p:extLst>
          </p:nvPr>
        </p:nvGraphicFramePr>
        <p:xfrm>
          <a:off x="1729408" y="1490079"/>
          <a:ext cx="7702826" cy="1391797"/>
        </p:xfrm>
        <a:graphic>
          <a:graphicData uri="http://schemas.openxmlformats.org/drawingml/2006/table">
            <a:tbl>
              <a:tblPr/>
              <a:tblGrid>
                <a:gridCol w="808836">
                  <a:extLst>
                    <a:ext uri="{9D8B030D-6E8A-4147-A177-3AD203B41FA5}">
                      <a16:colId xmlns:a16="http://schemas.microsoft.com/office/drawing/2014/main" val="1967222776"/>
                    </a:ext>
                  </a:extLst>
                </a:gridCol>
                <a:gridCol w="913589">
                  <a:extLst>
                    <a:ext uri="{9D8B030D-6E8A-4147-A177-3AD203B41FA5}">
                      <a16:colId xmlns:a16="http://schemas.microsoft.com/office/drawing/2014/main" val="798149335"/>
                    </a:ext>
                  </a:extLst>
                </a:gridCol>
                <a:gridCol w="557255">
                  <a:extLst>
                    <a:ext uri="{9D8B030D-6E8A-4147-A177-3AD203B41FA5}">
                      <a16:colId xmlns:a16="http://schemas.microsoft.com/office/drawing/2014/main" val="1031471795"/>
                    </a:ext>
                  </a:extLst>
                </a:gridCol>
                <a:gridCol w="942782">
                  <a:extLst>
                    <a:ext uri="{9D8B030D-6E8A-4147-A177-3AD203B41FA5}">
                      <a16:colId xmlns:a16="http://schemas.microsoft.com/office/drawing/2014/main" val="576673452"/>
                    </a:ext>
                  </a:extLst>
                </a:gridCol>
                <a:gridCol w="913589">
                  <a:extLst>
                    <a:ext uri="{9D8B030D-6E8A-4147-A177-3AD203B41FA5}">
                      <a16:colId xmlns:a16="http://schemas.microsoft.com/office/drawing/2014/main" val="1522753619"/>
                    </a:ext>
                  </a:extLst>
                </a:gridCol>
                <a:gridCol w="608773">
                  <a:extLst>
                    <a:ext uri="{9D8B030D-6E8A-4147-A177-3AD203B41FA5}">
                      <a16:colId xmlns:a16="http://schemas.microsoft.com/office/drawing/2014/main" val="3940573501"/>
                    </a:ext>
                  </a:extLst>
                </a:gridCol>
                <a:gridCol w="607055">
                  <a:extLst>
                    <a:ext uri="{9D8B030D-6E8A-4147-A177-3AD203B41FA5}">
                      <a16:colId xmlns:a16="http://schemas.microsoft.com/office/drawing/2014/main" val="193650148"/>
                    </a:ext>
                  </a:extLst>
                </a:gridCol>
                <a:gridCol w="638826">
                  <a:extLst>
                    <a:ext uri="{9D8B030D-6E8A-4147-A177-3AD203B41FA5}">
                      <a16:colId xmlns:a16="http://schemas.microsoft.com/office/drawing/2014/main" val="1488796466"/>
                    </a:ext>
                  </a:extLst>
                </a:gridCol>
                <a:gridCol w="1712121">
                  <a:extLst>
                    <a:ext uri="{9D8B030D-6E8A-4147-A177-3AD203B41FA5}">
                      <a16:colId xmlns:a16="http://schemas.microsoft.com/office/drawing/2014/main" val="151067348"/>
                    </a:ext>
                  </a:extLst>
                </a:gridCol>
              </a:tblGrid>
              <a:tr h="38162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rsion/%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50N,V52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57N*, T5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78N/Q80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94N/E96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110N, K112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136, R138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171, G173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tive (N207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1126781"/>
                  </a:ext>
                </a:extLst>
              </a:tr>
              <a:tr h="2501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8303899"/>
                  </a:ext>
                </a:extLst>
              </a:tr>
              <a:tr h="2501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3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9739341"/>
                  </a:ext>
                </a:extLst>
              </a:tr>
              <a:tr h="2501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4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443213"/>
                  </a:ext>
                </a:extLst>
              </a:tr>
              <a:tr h="2501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82**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--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225806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D7FBCD09-57FF-4AD8-8B4F-09777EAD99D1}"/>
              </a:ext>
            </a:extLst>
          </p:cNvPr>
          <p:cNvSpPr/>
          <p:nvPr/>
        </p:nvSpPr>
        <p:spPr>
          <a:xfrm>
            <a:off x="1729408" y="4855496"/>
            <a:ext cx="7941365" cy="6075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F57N is equivalent to F34N without N-terminal signal sequence of 23 </a:t>
            </a:r>
            <a:r>
              <a:rPr lang="en-US" sz="16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a</a:t>
            </a: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6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**v82 exhibited 5 N- or O-glycosylation sites including native N-glycosylation </a:t>
            </a:r>
            <a:endParaRPr lang="en-US" sz="1600" dirty="0"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28FC8C-D21B-41BE-8E77-3EB311CD6914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/>
          <a:p>
            <a:r>
              <a:rPr lang="en-US"/>
              <a:t>Amgen Proprietary - For Internal Use Onl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55708F-10ED-4EDD-88E9-27C014D5DBC8}"/>
              </a:ext>
            </a:extLst>
          </p:cNvPr>
          <p:cNvSpPr txBox="1"/>
          <p:nvPr/>
        </p:nvSpPr>
        <p:spPr>
          <a:xfrm>
            <a:off x="1838037" y="3130022"/>
            <a:ext cx="713699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 TIMP3 amino acid sequence: </a:t>
            </a:r>
          </a:p>
          <a:p>
            <a:r>
              <a:rPr lang="en-US" dirty="0"/>
              <a:t>1-CTCSPSHPQD AFCNSDIVIR AKVVGKKLVK EGPFGTLVYT IKQMKMYRGF </a:t>
            </a:r>
          </a:p>
          <a:p>
            <a:r>
              <a:rPr lang="en-US" dirty="0"/>
              <a:t>TKMPHVQYIH TEASESLCGL KLEVNKYQYL LTGRVYDGKM YTGLCNFVER </a:t>
            </a:r>
          </a:p>
          <a:p>
            <a:r>
              <a:rPr lang="en-US" dirty="0"/>
              <a:t>WDQLTLSQRK GLNYRYHLGC NCKIKSCYYL PCFVTSKNEC LWTDMLSNFG </a:t>
            </a:r>
          </a:p>
          <a:p>
            <a:r>
              <a:rPr lang="en-US" dirty="0"/>
              <a:t>YPGYQSKHYA CIRQKGGYCS WYRGWAPPDK SIINATDP-18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2588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DA0042-3B71-485C-BD2C-C434CCFD9D93}"/>
              </a:ext>
            </a:extLst>
          </p:cNvPr>
          <p:cNvSpPr txBox="1"/>
          <p:nvPr/>
        </p:nvSpPr>
        <p:spPr>
          <a:xfrm>
            <a:off x="704916" y="487262"/>
            <a:ext cx="6578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 Figure 1. Zymography in human LV and rat MI LV tissue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7FBCD09-57FF-4AD8-8B4F-09777EAD99D1}"/>
              </a:ext>
            </a:extLst>
          </p:cNvPr>
          <p:cNvSpPr/>
          <p:nvPr/>
        </p:nvSpPr>
        <p:spPr>
          <a:xfrm>
            <a:off x="1004141" y="5544314"/>
            <a:ext cx="10141323" cy="8649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Human heart LV tissue samples were from a postmortem heart failure donor and inhibited by TIMP3v2 (white bands).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6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) Rat cardiac tissues are collected from non-infarct remote, peri-infarct and infarcted area from 1-week post LAD ligated rat hearts. TIMP3v2 (1uM) interfered MMP activity in zymography.</a:t>
            </a: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28FC8C-D21B-41BE-8E77-3EB311CD6914}"/>
              </a:ext>
            </a:extLst>
          </p:cNvPr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/>
          <a:p>
            <a:r>
              <a:rPr lang="en-US"/>
              <a:t>Amgen Proprietary - For Internal Use Only</a:t>
            </a:r>
            <a:endParaRPr lang="en-US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6BC28D5-E5E5-49FF-8323-89F5BDC4D04D}"/>
              </a:ext>
            </a:extLst>
          </p:cNvPr>
          <p:cNvGrpSpPr/>
          <p:nvPr/>
        </p:nvGrpSpPr>
        <p:grpSpPr>
          <a:xfrm>
            <a:off x="520316" y="1235482"/>
            <a:ext cx="4787180" cy="4145617"/>
            <a:chOff x="3382785" y="1645155"/>
            <a:chExt cx="4787180" cy="4145617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E54033F-7D42-45A1-93EE-D365CBD8C3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595" t="4642" r="7896"/>
            <a:stretch/>
          </p:blipFill>
          <p:spPr>
            <a:xfrm>
              <a:off x="3814141" y="3264541"/>
              <a:ext cx="3888685" cy="252623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F8B1BCD-08C7-42D5-B1A4-E0E9C53AE080}"/>
                </a:ext>
              </a:extLst>
            </p:cNvPr>
            <p:cNvSpPr txBox="1"/>
            <p:nvPr/>
          </p:nvSpPr>
          <p:spPr>
            <a:xfrm>
              <a:off x="3393002" y="3777761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31E9897-11BD-4AC1-A404-005A3F253CCF}"/>
                </a:ext>
              </a:extLst>
            </p:cNvPr>
            <p:cNvSpPr txBox="1"/>
            <p:nvPr/>
          </p:nvSpPr>
          <p:spPr>
            <a:xfrm>
              <a:off x="3407830" y="3987367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5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376F498-A4E3-4CE2-9546-CED3B9F48C3F}"/>
                </a:ext>
              </a:extLst>
            </p:cNvPr>
            <p:cNvSpPr txBox="1"/>
            <p:nvPr/>
          </p:nvSpPr>
          <p:spPr>
            <a:xfrm>
              <a:off x="3382785" y="4209271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8A4FCDC-6993-4ABA-89FB-98D3799CAC04}"/>
                </a:ext>
              </a:extLst>
            </p:cNvPr>
            <p:cNvSpPr txBox="1"/>
            <p:nvPr/>
          </p:nvSpPr>
          <p:spPr>
            <a:xfrm>
              <a:off x="3460298" y="444703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2A3A144-6794-4D0C-99A5-3C3D15D8CA8C}"/>
                </a:ext>
              </a:extLst>
            </p:cNvPr>
            <p:cNvSpPr txBox="1"/>
            <p:nvPr/>
          </p:nvSpPr>
          <p:spPr>
            <a:xfrm>
              <a:off x="3460298" y="481554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BB684BC-7989-4E44-9976-A36084EBE792}"/>
                </a:ext>
              </a:extLst>
            </p:cNvPr>
            <p:cNvSpPr txBox="1"/>
            <p:nvPr/>
          </p:nvSpPr>
          <p:spPr>
            <a:xfrm>
              <a:off x="3446733" y="514927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81E695C-1B00-4209-87C4-F13090EEFC52}"/>
                </a:ext>
              </a:extLst>
            </p:cNvPr>
            <p:cNvSpPr txBox="1"/>
            <p:nvPr/>
          </p:nvSpPr>
          <p:spPr>
            <a:xfrm rot="11790809">
              <a:off x="3982205" y="2751008"/>
              <a:ext cx="369332" cy="49148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ladder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CB195EF3-D797-46C6-988A-A4EE003918DF}"/>
                </a:ext>
              </a:extLst>
            </p:cNvPr>
            <p:cNvCxnSpPr/>
            <p:nvPr/>
          </p:nvCxnSpPr>
          <p:spPr>
            <a:xfrm flipH="1">
              <a:off x="4782191" y="2371289"/>
              <a:ext cx="1604" cy="958734"/>
            </a:xfrm>
            <a:prstGeom prst="line">
              <a:avLst/>
            </a:prstGeom>
            <a:ln w="381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13713C-3C58-482F-A36E-7B07679FEDDC}"/>
                </a:ext>
              </a:extLst>
            </p:cNvPr>
            <p:cNvSpPr txBox="1"/>
            <p:nvPr/>
          </p:nvSpPr>
          <p:spPr>
            <a:xfrm rot="11790809">
              <a:off x="4369100" y="2527843"/>
              <a:ext cx="369332" cy="79784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Human LV*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CCCCB31-7761-42E5-A85C-18C8E957B600}"/>
                </a:ext>
              </a:extLst>
            </p:cNvPr>
            <p:cNvSpPr txBox="1"/>
            <p:nvPr/>
          </p:nvSpPr>
          <p:spPr>
            <a:xfrm>
              <a:off x="5623016" y="1645155"/>
              <a:ext cx="10086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MP3v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3221B71-BEDF-4094-8AE2-9FF1B4ACE0AF}"/>
                </a:ext>
              </a:extLst>
            </p:cNvPr>
            <p:cNvSpPr txBox="1"/>
            <p:nvPr/>
          </p:nvSpPr>
          <p:spPr>
            <a:xfrm>
              <a:off x="4224894" y="204812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DF9EF32-9FA2-418A-AD63-D2982B4045BD}"/>
                </a:ext>
              </a:extLst>
            </p:cNvPr>
            <p:cNvSpPr txBox="1"/>
            <p:nvPr/>
          </p:nvSpPr>
          <p:spPr>
            <a:xfrm>
              <a:off x="4803970" y="2036840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nM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1371C92-4923-4E5F-A029-26507C0E10A6}"/>
                </a:ext>
              </a:extLst>
            </p:cNvPr>
            <p:cNvSpPr txBox="1"/>
            <p:nvPr/>
          </p:nvSpPr>
          <p:spPr>
            <a:xfrm rot="11790809">
              <a:off x="4762735" y="2740857"/>
              <a:ext cx="369332" cy="49148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ladder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3D3BA83-31A4-47AC-BB0B-F0163370F38F}"/>
                </a:ext>
              </a:extLst>
            </p:cNvPr>
            <p:cNvSpPr txBox="1"/>
            <p:nvPr/>
          </p:nvSpPr>
          <p:spPr>
            <a:xfrm rot="11790809">
              <a:off x="5131501" y="2593138"/>
              <a:ext cx="369332" cy="72090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Human LV</a:t>
              </a: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F58B7B49-27AA-4859-8132-AF5A3A0E3AE7}"/>
                </a:ext>
              </a:extLst>
            </p:cNvPr>
            <p:cNvCxnSpPr/>
            <p:nvPr/>
          </p:nvCxnSpPr>
          <p:spPr>
            <a:xfrm flipH="1">
              <a:off x="5471459" y="2377323"/>
              <a:ext cx="1604" cy="958734"/>
            </a:xfrm>
            <a:prstGeom prst="line">
              <a:avLst/>
            </a:prstGeom>
            <a:ln w="381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F3FF891-B79E-4253-B254-CCAE8F91A1E5}"/>
                </a:ext>
              </a:extLst>
            </p:cNvPr>
            <p:cNvSpPr txBox="1"/>
            <p:nvPr/>
          </p:nvSpPr>
          <p:spPr>
            <a:xfrm rot="11790809">
              <a:off x="5464297" y="2770820"/>
              <a:ext cx="369332" cy="49148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ladder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571EA7C-6EAD-4C64-A9B1-93B9B1C8BF97}"/>
                </a:ext>
              </a:extLst>
            </p:cNvPr>
            <p:cNvSpPr txBox="1"/>
            <p:nvPr/>
          </p:nvSpPr>
          <p:spPr>
            <a:xfrm rot="11790809">
              <a:off x="5813517" y="2576861"/>
              <a:ext cx="369332" cy="72090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Human LV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E27D6F-72F0-4147-902E-A70300913FFD}"/>
                </a:ext>
              </a:extLst>
            </p:cNvPr>
            <p:cNvSpPr txBox="1"/>
            <p:nvPr/>
          </p:nvSpPr>
          <p:spPr>
            <a:xfrm>
              <a:off x="5510357" y="2021626"/>
              <a:ext cx="6158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nM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887F19A-238B-4123-BEAA-CE80A4AD52AC}"/>
                </a:ext>
              </a:extLst>
            </p:cNvPr>
            <p:cNvCxnSpPr/>
            <p:nvPr/>
          </p:nvCxnSpPr>
          <p:spPr>
            <a:xfrm flipH="1">
              <a:off x="6876187" y="2330943"/>
              <a:ext cx="1604" cy="958734"/>
            </a:xfrm>
            <a:prstGeom prst="line">
              <a:avLst/>
            </a:prstGeom>
            <a:ln w="381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A6599C5-ED8C-42B9-8992-4DFAC31DDB3C}"/>
                </a:ext>
              </a:extLst>
            </p:cNvPr>
            <p:cNvSpPr txBox="1"/>
            <p:nvPr/>
          </p:nvSpPr>
          <p:spPr>
            <a:xfrm rot="11790809">
              <a:off x="6918852" y="2770821"/>
              <a:ext cx="369332" cy="49148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ladder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C1B664D-28A8-48B5-AB6D-29BBE2558CF4}"/>
                </a:ext>
              </a:extLst>
            </p:cNvPr>
            <p:cNvSpPr txBox="1"/>
            <p:nvPr/>
          </p:nvSpPr>
          <p:spPr>
            <a:xfrm rot="11790809">
              <a:off x="7294759" y="2556839"/>
              <a:ext cx="369332" cy="72090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Human LV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52B4FE5-6E29-47C4-912C-F1989F32B0B8}"/>
                </a:ext>
              </a:extLst>
            </p:cNvPr>
            <p:cNvSpPr txBox="1"/>
            <p:nvPr/>
          </p:nvSpPr>
          <p:spPr>
            <a:xfrm>
              <a:off x="6974719" y="1995124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uM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DAB22E57-3F62-451C-8ECA-57CE5CFCFD8E}"/>
                </a:ext>
              </a:extLst>
            </p:cNvPr>
            <p:cNvCxnSpPr/>
            <p:nvPr/>
          </p:nvCxnSpPr>
          <p:spPr>
            <a:xfrm flipH="1">
              <a:off x="6163879" y="2354136"/>
              <a:ext cx="1604" cy="958734"/>
            </a:xfrm>
            <a:prstGeom prst="line">
              <a:avLst/>
            </a:prstGeom>
            <a:ln w="381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6F81AF1-A0E3-4D6E-A415-FB58C01D7C3C}"/>
                </a:ext>
              </a:extLst>
            </p:cNvPr>
            <p:cNvSpPr txBox="1"/>
            <p:nvPr/>
          </p:nvSpPr>
          <p:spPr>
            <a:xfrm rot="11790809">
              <a:off x="6149028" y="2779036"/>
              <a:ext cx="369332" cy="49148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ladder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4510E66-9F65-43B5-941E-6423585DF269}"/>
                </a:ext>
              </a:extLst>
            </p:cNvPr>
            <p:cNvSpPr txBox="1"/>
            <p:nvPr/>
          </p:nvSpPr>
          <p:spPr>
            <a:xfrm rot="11790809">
              <a:off x="6505937" y="2603369"/>
              <a:ext cx="369332" cy="72090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200" dirty="0"/>
                <a:t>Human LV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F93DD0B-8E12-4E90-8011-5BC7B271CD18}"/>
                </a:ext>
              </a:extLst>
            </p:cNvPr>
            <p:cNvSpPr txBox="1"/>
            <p:nvPr/>
          </p:nvSpPr>
          <p:spPr>
            <a:xfrm>
              <a:off x="6202777" y="1998439"/>
              <a:ext cx="7072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0nM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022553C9-1E95-4425-ADAC-EB3810639E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58930" y="4447030"/>
              <a:ext cx="411035" cy="0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id="{EDA5451E-2AD2-40CC-82D2-242A9E94EC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76388" y="2856321"/>
            <a:ext cx="4787312" cy="252477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152EEF13-3248-477E-983F-A108B4546DBB}"/>
              </a:ext>
            </a:extLst>
          </p:cNvPr>
          <p:cNvSpPr txBox="1"/>
          <p:nvPr/>
        </p:nvSpPr>
        <p:spPr>
          <a:xfrm rot="11790809">
            <a:off x="10899530" y="2081122"/>
            <a:ext cx="369332" cy="7725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Rec MMP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5D3904-A6F6-43EE-B41F-AC4A4995A2B7}"/>
              </a:ext>
            </a:extLst>
          </p:cNvPr>
          <p:cNvSpPr txBox="1"/>
          <p:nvPr/>
        </p:nvSpPr>
        <p:spPr>
          <a:xfrm rot="11790809">
            <a:off x="9765188" y="2229191"/>
            <a:ext cx="369332" cy="49494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Infarc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A372953-D9F3-4117-A93D-4FD7AB30D3AD}"/>
              </a:ext>
            </a:extLst>
          </p:cNvPr>
          <p:cNvSpPr txBox="1"/>
          <p:nvPr/>
        </p:nvSpPr>
        <p:spPr>
          <a:xfrm rot="11790809">
            <a:off x="7889037" y="2322572"/>
            <a:ext cx="369332" cy="49494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Infarc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914A2DA-7450-4F81-ABF4-0EE21F7C0A0F}"/>
              </a:ext>
            </a:extLst>
          </p:cNvPr>
          <p:cNvSpPr txBox="1"/>
          <p:nvPr/>
        </p:nvSpPr>
        <p:spPr>
          <a:xfrm rot="11790809">
            <a:off x="8811210" y="2054844"/>
            <a:ext cx="369332" cy="79951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Non-infarc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2FF62D2-FC9A-4566-8045-1DE87EE54AC8}"/>
              </a:ext>
            </a:extLst>
          </p:cNvPr>
          <p:cNvSpPr txBox="1"/>
          <p:nvPr/>
        </p:nvSpPr>
        <p:spPr>
          <a:xfrm rot="11790809">
            <a:off x="7009729" y="2027240"/>
            <a:ext cx="369332" cy="79951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Non-infarc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06F0B6A-6557-4FAF-BDAC-9730EB106BDB}"/>
              </a:ext>
            </a:extLst>
          </p:cNvPr>
          <p:cNvSpPr txBox="1"/>
          <p:nvPr/>
        </p:nvSpPr>
        <p:spPr>
          <a:xfrm rot="11790809">
            <a:off x="9329839" y="2057438"/>
            <a:ext cx="369332" cy="78040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Peri-infarc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2D1D8F3-E33C-476C-97B6-7E7D6A06D448}"/>
              </a:ext>
            </a:extLst>
          </p:cNvPr>
          <p:cNvSpPr txBox="1"/>
          <p:nvPr/>
        </p:nvSpPr>
        <p:spPr>
          <a:xfrm rot="11790809">
            <a:off x="7456127" y="2101716"/>
            <a:ext cx="369332" cy="78040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Peri-infarc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5967F24-231E-4874-8932-DD75A075C153}"/>
              </a:ext>
            </a:extLst>
          </p:cNvPr>
          <p:cNvSpPr txBox="1"/>
          <p:nvPr/>
        </p:nvSpPr>
        <p:spPr>
          <a:xfrm rot="11790809">
            <a:off x="8422801" y="1724145"/>
            <a:ext cx="369332" cy="11585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Infarct+TIMP3v2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369DE09-AD5E-4219-BC2F-928EFFB4E63C}"/>
              </a:ext>
            </a:extLst>
          </p:cNvPr>
          <p:cNvSpPr txBox="1"/>
          <p:nvPr/>
        </p:nvSpPr>
        <p:spPr>
          <a:xfrm rot="11790809">
            <a:off x="10307848" y="1727169"/>
            <a:ext cx="369332" cy="112332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/>
              <a:t>Infarct+TIMP3v2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B5A1C427-6FE6-4494-8060-25104240AE35}"/>
              </a:ext>
            </a:extLst>
          </p:cNvPr>
          <p:cNvCxnSpPr/>
          <p:nvPr/>
        </p:nvCxnSpPr>
        <p:spPr>
          <a:xfrm>
            <a:off x="7194395" y="1706679"/>
            <a:ext cx="151080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FB5BE36D-7E8F-4DCB-B269-1ADE90D90EED}"/>
              </a:ext>
            </a:extLst>
          </p:cNvPr>
          <p:cNvCxnSpPr/>
          <p:nvPr/>
        </p:nvCxnSpPr>
        <p:spPr>
          <a:xfrm>
            <a:off x="9106806" y="1706679"/>
            <a:ext cx="151080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E4DA8685-49A7-4621-9BA4-7FFA8341374D}"/>
              </a:ext>
            </a:extLst>
          </p:cNvPr>
          <p:cNvSpPr txBox="1"/>
          <p:nvPr/>
        </p:nvSpPr>
        <p:spPr>
          <a:xfrm rot="16200000">
            <a:off x="7682847" y="1046968"/>
            <a:ext cx="400110" cy="9194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MI Rat-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5F7A041-988A-4B6C-8E36-E48B0138FA3B}"/>
              </a:ext>
            </a:extLst>
          </p:cNvPr>
          <p:cNvSpPr txBox="1"/>
          <p:nvPr/>
        </p:nvSpPr>
        <p:spPr>
          <a:xfrm rot="16200000">
            <a:off x="9638883" y="1130412"/>
            <a:ext cx="400110" cy="7784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 Rat-2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A3FFBA21-1DF3-4547-A061-A62F84B4847E}"/>
              </a:ext>
            </a:extLst>
          </p:cNvPr>
          <p:cNvCxnSpPr>
            <a:cxnSpLocks/>
          </p:cNvCxnSpPr>
          <p:nvPr/>
        </p:nvCxnSpPr>
        <p:spPr>
          <a:xfrm flipH="1">
            <a:off x="11371036" y="3697848"/>
            <a:ext cx="396894" cy="0"/>
          </a:xfrm>
          <a:prstGeom prst="straightConnector1">
            <a:avLst/>
          </a:prstGeom>
          <a:ln w="5715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7E41FE4D-9A16-4B2B-99A0-8E70955E9766}"/>
              </a:ext>
            </a:extLst>
          </p:cNvPr>
          <p:cNvSpPr txBox="1"/>
          <p:nvPr/>
        </p:nvSpPr>
        <p:spPr>
          <a:xfrm>
            <a:off x="870823" y="121132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C5C5EED-A899-4A1F-B38C-1FE43515F052}"/>
              </a:ext>
            </a:extLst>
          </p:cNvPr>
          <p:cNvSpPr txBox="1"/>
          <p:nvPr/>
        </p:nvSpPr>
        <p:spPr>
          <a:xfrm>
            <a:off x="6300374" y="120427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4716853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For Internal Use Onl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f057fdcd-f1c4-417c-a7f8-9d10d102e03d" value=""/>
  <element uid="9036a7a1-5a4f-48d3-b24b-dfdab053dac9" value=""/>
  <element uid="03e9b10b-a1f9-4a88-9630-476473f62285" value=""/>
</sisl>
</file>

<file path=customXml/itemProps1.xml><?xml version="1.0" encoding="utf-8"?>
<ds:datastoreItem xmlns:ds="http://schemas.openxmlformats.org/officeDocument/2006/customXml" ds:itemID="{FF064C91-1D24-40B5-A2C5-2BC1FF239DD9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9</TotalTime>
  <Words>281</Words>
  <Application>Microsoft Office PowerPoint</Application>
  <PresentationFormat>Widescreen</PresentationFormat>
  <Paragraphs>9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Taeweon</dc:creator>
  <cp:keywords>*$%IU-*$%GenBus</cp:keywords>
  <cp:lastModifiedBy>Lee, Taeweon</cp:lastModifiedBy>
  <cp:revision>16</cp:revision>
  <dcterms:created xsi:type="dcterms:W3CDTF">2018-10-05T18:38:33Z</dcterms:created>
  <dcterms:modified xsi:type="dcterms:W3CDTF">2018-10-05T23:58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f151c90a-2332-4e0e-8e00-7b723dc67169</vt:lpwstr>
  </property>
  <property fmtid="{D5CDD505-2E9C-101B-9397-08002B2CF9AE}" pid="3" name="bjSaver">
    <vt:lpwstr>nmm4iB+rET/Kd6l/yJIYXQL+cOD122FW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f057fdcd-f1c4-417c-a7f8-9d10d102e03d" value="" /&gt;&lt;element uid="9036a7a1-5a4f-48d3-b24b-dfdab053dac9" value="" /&gt;&lt;element uid="03e9b10b-a1f9-4a88-9630-476473f62285" value="" /&gt;&lt;/sisl&gt;</vt:lpwstr>
  </property>
  <property fmtid="{D5CDD505-2E9C-101B-9397-08002B2CF9AE}" pid="6" name="bjDocumentSecurityLabel">
    <vt:lpwstr>Internal Use Only - General Business</vt:lpwstr>
  </property>
</Properties>
</file>